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06_1450F4F3.xml" ContentType="application/vnd.ms-powerpoint.comment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8" r:id="rId6"/>
    <p:sldId id="263" r:id="rId7"/>
    <p:sldId id="264" r:id="rId8"/>
    <p:sldId id="265" r:id="rId9"/>
    <p:sldId id="266" r:id="rId10"/>
    <p:sldId id="262" r:id="rId11"/>
    <p:sldId id="271" r:id="rId12"/>
    <p:sldId id="273" r:id="rId13"/>
    <p:sldId id="272" r:id="rId14"/>
    <p:sldId id="269" r:id="rId15"/>
    <p:sldId id="270" r:id="rId16"/>
    <p:sldId id="274" r:id="rId17"/>
    <p:sldId id="257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9364303-4B23-97F1-DA91-F1CA3064EB2B}" name="i.chai.2008@gmail.com" initials="i." userId="S::urn:spo:guest#i.chai.2008@gmail.com::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8/10/relationships/authors" Target="authors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comments/modernComment_106_1450F4F3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AC0AA6E0-C73E-4D49-A9B8-8978DD538D19}" authorId="{59364303-4B23-97F1-DA91-F1CA3064EB2B}" created="2022-10-26T01:37:41.374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340849907" sldId="262"/>
      <ac:picMk id="28" creationId="{EA2C3110-07AA-D7A2-A16F-3B3754D25E7E}"/>
    </ac:deMkLst>
    <p188:txBody>
      <a:bodyPr/>
      <a:lstStyle/>
      <a:p>
        <a:r>
          <a:rPr lang="en-US"/>
          <a:t>Added in the raw photos to show edges of the blots per comments.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5032BF-E63F-8A5E-A636-8C9AF829B4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2FE920-101C-BF3D-17F6-2C200C4B65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6912B1-27FF-F355-41B1-97EEFE950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33ED7A-E7D9-8903-34B1-020B3ED7D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43836-136E-96BC-B872-706229CB5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F542F5-8EF0-71FC-4907-1C4775E02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F93504-48CE-C175-AEA3-7CF5AD69C1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46BD8-EE71-F55D-D9A7-9048DD968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93B705-1126-F6DC-4173-73B7E753C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B326DE-DE21-358D-A0D7-33647A74C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724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E0FFF1-9BA0-DAF3-4538-2E2AEC6A42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3678D8D-7EC5-2337-26E8-664A9B2194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AC848-A4C2-F98A-8F15-9C3004BDB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8042A-8882-66F5-C8FE-23EAC47B1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2F98A7-FCD8-8E41-9203-D9AF32341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097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5D74A-1B94-B852-0C93-E337D46EA0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9DB494-B2FE-4350-F2D4-64D8CB179B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CAC7B-90CD-3B9D-B58E-6D713260B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D80559-E8C0-74EF-CFDC-30A6F50DF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E3670-C2BC-B77C-59E3-0CAFD3FCB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377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575D6-3B9B-013A-C1D9-B533C9C7F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DEBC66-FBEB-E2FA-24ED-AB80D8C79F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D2F1C8-A781-EB3A-4556-48F4B800D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0CDC9-EE38-0C69-D4CA-55C8E62AC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5943BF-2E0B-67E4-64E5-E3C074B89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157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F0287A-2539-55EA-C82F-EA95AFCFE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3C774C-B61B-A82D-3200-3B8CCD4159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B99115-C386-34A7-A075-E9745FACD1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D46894-DF32-B629-847C-00702F422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EC6DF8-0DB7-8748-C306-CBC11644D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946226-8031-9CCA-41F6-74827DE6E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431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C5FAE-F658-6C59-A9CB-1FC86B144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94D671-45DC-31AF-854B-EF7C19DF68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A75BFF-B7FD-A4BA-5338-1DCDF3894A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3668D8-473B-600F-4AD9-6EAB5CC243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3226A3-D30C-8791-EBFC-1DE505A45D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57AA7E-BF5D-C0FE-D20C-4BC93E79F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19716C-1971-0919-00FA-3B93A84B1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9E8DED-2408-5B48-177F-842F4A9F8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37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636CD-5E32-975E-C63D-12F3066088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40F95D-FE18-E5CE-2C2C-11F5C3952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00E357-EEF8-6D57-CE20-262E784E1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5373719-596A-DB36-A92E-16EBF23BE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516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6E4129-B376-579B-16AA-83545D27F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CAAE84-9196-CE4F-9FCD-6B9BAF8DD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B5F9FD-86D5-B036-2B2D-745F18C1C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602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790C0-58C0-A2D8-D849-C78853F1C2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F0D067-2B33-652D-FC4F-B84FBD3B47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B775E7-8467-40ED-98BE-C1875858BA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54A5FB-7706-09FD-797D-53ABE64AD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590288-843B-34DE-3C55-4A372B86C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1FEEE6-B1D3-20A2-D2EF-94D5A176A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20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3399F-E7D2-B6AB-9440-B2880F827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386022-0C8E-BFCB-A767-8255855643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DA55FB-CE6F-05CB-04CE-9F00BA83EE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818F09-7A29-D874-DBF4-CD2A79EB7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2A4F9E-4824-803F-B062-A6AF91178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82C5D1-6E1D-B407-FABF-8FC962AB4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528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832ABE-9C21-6951-E04D-F94EB174C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ADA403-761D-000B-2FDA-01AEDB8E4B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AFE090-AF2A-D79A-30FC-8BEF46DF7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67A8E-88E1-4ED0-8150-F9C6681FD04C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AC82E-92DD-A2CB-F184-CF3227D7E8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F7747-BA48-E105-7FC0-F9B58CAB92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784CE-9B84-4418-9547-EFCCAF168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87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microsoft.com/office/2018/10/relationships/comments" Target="../comments/modernComment_106_1450F4F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637C4-2AF7-9DBB-0FA3-EECA11CE710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upplemental data inform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4EE47F-92BC-B39A-CF21-7F0FED3214F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1425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3:  </a:t>
            </a:r>
            <a:endParaRPr lang="en-US" dirty="0"/>
          </a:p>
        </p:txBody>
      </p:sp>
      <p:pic>
        <p:nvPicPr>
          <p:cNvPr id="3" name="Picture 3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343BE98D-FBE8-200A-92F1-6A44670EB9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83601"/>
            <a:ext cx="6959600" cy="510049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FE450D-48D1-449A-FE17-D47DE8165C8D}"/>
              </a:ext>
            </a:extLst>
          </p:cNvPr>
          <p:cNvSpPr txBox="1"/>
          <p:nvPr/>
        </p:nvSpPr>
        <p:spPr>
          <a:xfrm>
            <a:off x="7217627" y="1582965"/>
            <a:ext cx="4761704" cy="452431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ea typeface="+mn-lt"/>
                <a:cs typeface="+mn-lt"/>
              </a:rPr>
              <a:t>Confocal images of MDA-MB-231-GFP cells (wildtype and PD-L1 knockout) fixed in ice-cold methanol. PD-L1 was detected with anti-PD-L1 antibody (ab209960, clone 28-8, conjugated with Alexa Fluor 647). The antibody was applied after fixation in ice-cold methanol and blocking with 2% BSA.  PD-L1-knockout cells had significantly lower signal in comparison to the background genotype. However, even in PD-L1 knockout the signal from ab209960 antibody was strong in the cells undergoing mitosis. The influence of this signal on the estimation of the PD-L1 level at the cell surface was deemed to be minimal because the percentage of mitotic cells is relatively low and the non-specific signal was predominantly localized in the intracellular space.</a:t>
            </a:r>
            <a:endParaRPr lang="en-US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050246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4:  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F3DE8C-4F87-F242-46FB-4E24A8BB2AF2}"/>
              </a:ext>
            </a:extLst>
          </p:cNvPr>
          <p:cNvSpPr txBox="1"/>
          <p:nvPr/>
        </p:nvSpPr>
        <p:spPr>
          <a:xfrm>
            <a:off x="7532406" y="122465"/>
            <a:ext cx="4662825" cy="646330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ea typeface="+mn-lt"/>
                <a:cs typeface="+mn-lt"/>
              </a:rPr>
              <a:t>Confocal images of MDA-MB-231 cells treated with either DMSO (top row) or GS-4224 (1 µM for 30 min, bottom row) demonstrating internalization of PD-L1 under conditions when detection antibody was present before addition if the compound dimerizing PD-L1.  The data were analyzed using </a:t>
            </a:r>
            <a:r>
              <a:rPr lang="en-US" dirty="0" err="1">
                <a:ea typeface="+mn-lt"/>
                <a:cs typeface="+mn-lt"/>
              </a:rPr>
              <a:t>Imaris</a:t>
            </a:r>
            <a:r>
              <a:rPr lang="en-US" dirty="0">
                <a:ea typeface="+mn-lt"/>
                <a:cs typeface="+mn-lt"/>
              </a:rPr>
              <a:t> software (Oxford Instruments, Abingdon, United Kingdom). Second column of images illustrates the colocalization analysis, when individual pixels are plotted based on their intensity in PD-L1 (red) channel and plasma membrane marker Na/K- ATPase (green) cannel and arbitrary thresholds were applied to identify which pixels are positive for both targets. The colocalization was calculated taking into account both the percentage of double-positive pixels as well as their intensity (% material colocalized).  The graph shows the decrease in the percentage of PD-L1 co-localized with Na+/K+-ATPase after  incubation with GS-4224. Data are mean ± S.D. (n=8-12 microscopic fields).</a:t>
            </a:r>
            <a:endParaRPr lang="en-US" dirty="0">
              <a:cs typeface="Calibri"/>
            </a:endParaRPr>
          </a:p>
        </p:txBody>
      </p:sp>
      <p:pic>
        <p:nvPicPr>
          <p:cNvPr id="8" name="Picture 8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57587A95-2EC9-9A27-45F2-C99A54EFD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614" y="1524050"/>
            <a:ext cx="7342414" cy="4667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32444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5:  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48D7AC-99C7-F831-03DD-83C42A1D3E30}"/>
              </a:ext>
            </a:extLst>
          </p:cNvPr>
          <p:cNvSpPr txBox="1"/>
          <p:nvPr/>
        </p:nvSpPr>
        <p:spPr>
          <a:xfrm>
            <a:off x="6455627" y="1443265"/>
            <a:ext cx="5422104" cy="397031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ea typeface="+mn-lt"/>
                <a:cs typeface="+mn-lt"/>
              </a:rPr>
              <a:t>Confocal images of MDA-MB-231-GFP cells treated with either DMSO or 10 µM GS-4224 for 24 h at 37oC.  Cells treated with the inhibitor inducing dimerization of PD-L1 (GS-4224) have stronger intracellular signal in comparison to DMSO-treated cells with more pronounced PD-L1 localization at the plasma membrane. This can be interpreted as compound-induced accumulation/retention of PD-L1 in ER region.  Note that the strength of this effect may depend on the level of PD-L1 expression. PD-L1 was detected with anti-PD-L1 antibody (ab209960) conjugated with Alexa Fluor 647. The antibody was applied after fixation in ice-cold methanol and blocking with 2% BSA.  </a:t>
            </a:r>
          </a:p>
        </p:txBody>
      </p:sp>
      <p:pic>
        <p:nvPicPr>
          <p:cNvPr id="12" name="Picture 12" descr="Background pattern&#10;&#10;Description automatically generated">
            <a:extLst>
              <a:ext uri="{FF2B5EF4-FFF2-40B4-BE49-F238E27FC236}">
                <a16:creationId xmlns:a16="http://schemas.microsoft.com/office/drawing/2014/main" id="{F42E602D-4C37-6BC8-8E66-9D762544A7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431352"/>
            <a:ext cx="5245100" cy="4960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8814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6:  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009D8F9-C33C-332A-E014-74A6F844B807}"/>
              </a:ext>
            </a:extLst>
          </p:cNvPr>
          <p:cNvSpPr txBox="1"/>
          <p:nvPr/>
        </p:nvSpPr>
        <p:spPr>
          <a:xfrm>
            <a:off x="7928827" y="1341665"/>
            <a:ext cx="4126704" cy="424731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cs typeface="Calibri"/>
              </a:rPr>
              <a:t>Confocal images of </a:t>
            </a:r>
            <a:r>
              <a:rPr lang="en-US" dirty="0" err="1">
                <a:cs typeface="Calibri"/>
              </a:rPr>
              <a:t>ExpiCHO</a:t>
            </a:r>
            <a:r>
              <a:rPr lang="en-US" dirty="0">
                <a:ea typeface="+mn-lt"/>
                <a:cs typeface="+mn-lt"/>
              </a:rPr>
              <a:t> and Expi293 cells transfected with either EYFP-PD-L1 or EYFP-PD-L2 and treated with either 0.1% DMSO or compounds (10  </a:t>
            </a:r>
            <a:r>
              <a:rPr lang="en-GB" dirty="0">
                <a:ea typeface="+mn-lt"/>
                <a:cs typeface="+mn-lt"/>
              </a:rPr>
              <a:t>µ</a:t>
            </a:r>
            <a:r>
              <a:rPr lang="en-US" dirty="0">
                <a:ea typeface="+mn-lt"/>
                <a:cs typeface="+mn-lt"/>
              </a:rPr>
              <a:t>M) that either dimerize (compounds A,B,C) or do not dimerize (macrocycle) PD-L1.  The cells were imaged live after 1-hour treatment.</a:t>
            </a:r>
            <a:r>
              <a:rPr lang="en-US" dirty="0">
                <a:cs typeface="Calibri"/>
              </a:rPr>
              <a:t> Dimerizing compounds induce formation of spherical structures resembling OSER (organized smooth  endoplasmic reticulum) in cells expressing EYFP-labeled recombinant PD-L1 protein. No such structures occurred when compounds were applied to the cells expressing EYFP-labeled PD-L2. </a:t>
            </a:r>
            <a:endParaRPr lang="en-US" dirty="0"/>
          </a:p>
        </p:txBody>
      </p:sp>
      <p:pic>
        <p:nvPicPr>
          <p:cNvPr id="8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7A987D09-1132-DCF1-2914-8BFDA6E8A2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" y="1490036"/>
            <a:ext cx="7416800" cy="3979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66979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69F0B-BC55-771B-AF63-64E6ACCF7F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7: for Pulse chase (Methods section, page 20)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31CBE8E4-B2BB-4726-8613-282BD4DC7C91}"/>
              </a:ext>
            </a:extLst>
          </p:cNvPr>
          <p:cNvSpPr>
            <a:spLocks noGrp="1"/>
          </p:cNvSpPr>
          <p:nvPr/>
        </p:nvSpPr>
        <p:spPr>
          <a:xfrm>
            <a:off x="2680801" y="1690688"/>
            <a:ext cx="6642335" cy="476250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lvl1pPr marL="0" indent="0" algn="l" defTabSz="914400" rtl="0" eaLnBrk="1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sz="2000" b="0" i="0" kern="1600" spc="-50" baseline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1pPr>
            <a:lvl2pPr marL="290513" indent="-174625" algn="l" defTabSz="914400" rtl="0" eaLnBrk="1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Font typeface="Apple Symbols" panose="02000000000000000000" pitchFamily="2" charset="-79"/>
              <a:buChar char="⎼"/>
              <a:tabLst/>
              <a:defRPr lang="en-US" sz="1800" b="0" i="1" kern="1600" spc="-50" baseline="0" dirty="0">
                <a:solidFill>
                  <a:schemeClr val="tx1"/>
                </a:solidFill>
                <a:latin typeface="Georgia" panose="02040502050405020303" pitchFamily="18" charset="0"/>
                <a:ea typeface="+mn-ea"/>
                <a:cs typeface="+mn-cs"/>
              </a:defRPr>
            </a:lvl2pPr>
            <a:lvl3pPr marL="403225" indent="-285750" algn="l" defTabSz="914400" rtl="0" eaLnBrk="1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Font typeface="Apple Symbols" panose="02000000000000000000" pitchFamily="2" charset="-79"/>
              <a:buChar char="⎼"/>
              <a:tabLst/>
              <a:defRPr lang="en-US" sz="160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3pPr>
            <a:lvl4pPr marL="809625" indent="-285750" algn="l" defTabSz="914400" rtl="0" eaLnBrk="1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Font typeface="Apple Symbols" panose="02000000000000000000" pitchFamily="2" charset="-79"/>
              <a:buChar char="⎼"/>
              <a:tabLst/>
              <a:defRPr lang="en-US" sz="1400" b="0" i="0" kern="1600" spc="-50" baseline="0" dirty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4pPr>
            <a:lvl5pPr marL="1376363" indent="-174625" algn="l" defTabSz="914400" rtl="0" eaLnBrk="1" latinLnBrk="0" hangingPunct="1">
              <a:lnSpc>
                <a:spcPct val="114000"/>
              </a:lnSpc>
              <a:spcBef>
                <a:spcPts val="0"/>
              </a:spcBef>
              <a:spcAft>
                <a:spcPts val="600"/>
              </a:spcAft>
              <a:buFont typeface="Apple Symbols" panose="02000000000000000000" pitchFamily="2" charset="-79"/>
              <a:buChar char="⎼"/>
              <a:tabLst/>
              <a:defRPr sz="1200" b="0" i="0" kern="1600" spc="-50" baseline="0">
                <a:solidFill>
                  <a:schemeClr val="tx1"/>
                </a:solidFill>
                <a:latin typeface="Trebuchet MS" panose="020B0703020202090204" pitchFamily="34" charset="0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000" b="1"/>
              <a:t>SILAC</a:t>
            </a:r>
            <a:r>
              <a:rPr lang="en-US" sz="2000"/>
              <a:t> (</a:t>
            </a:r>
            <a:r>
              <a:rPr lang="en-US" sz="2000" b="1"/>
              <a:t>S</a:t>
            </a:r>
            <a:r>
              <a:rPr lang="en-US" sz="2000"/>
              <a:t>table </a:t>
            </a:r>
            <a:r>
              <a:rPr lang="en-US" sz="2000" b="1"/>
              <a:t>I</a:t>
            </a:r>
            <a:r>
              <a:rPr lang="en-US" sz="2000"/>
              <a:t>sotope </a:t>
            </a:r>
            <a:r>
              <a:rPr lang="en-US" sz="2000" b="1"/>
              <a:t>L</a:t>
            </a:r>
            <a:r>
              <a:rPr lang="en-US" sz="2000"/>
              <a:t>abeling of </a:t>
            </a:r>
            <a:r>
              <a:rPr lang="en-US" sz="2000" b="1"/>
              <a:t>A</a:t>
            </a:r>
            <a:r>
              <a:rPr lang="en-US" sz="2000"/>
              <a:t>mino acids in cell </a:t>
            </a:r>
            <a:r>
              <a:rPr lang="en-US" sz="2000" b="1"/>
              <a:t>C</a:t>
            </a:r>
            <a:r>
              <a:rPr lang="en-US" sz="2000"/>
              <a:t>ulture)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C5F21BF-28B9-437E-A31C-A173FFF004DC}"/>
              </a:ext>
            </a:extLst>
          </p:cNvPr>
          <p:cNvGrpSpPr/>
          <p:nvPr/>
        </p:nvGrpSpPr>
        <p:grpSpPr>
          <a:xfrm>
            <a:off x="814325" y="3163495"/>
            <a:ext cx="671336" cy="383425"/>
            <a:chOff x="1219200" y="1905000"/>
            <a:chExt cx="533400" cy="215317"/>
          </a:xfrm>
        </p:grpSpPr>
        <p:sp>
          <p:nvSpPr>
            <p:cNvPr id="62" name="Oval 61">
              <a:extLst>
                <a:ext uri="{FF2B5EF4-FFF2-40B4-BE49-F238E27FC236}">
                  <a16:creationId xmlns:a16="http://schemas.microsoft.com/office/drawing/2014/main" id="{143DB59D-3B31-4EB1-9A16-E740F0204442}"/>
                </a:ext>
              </a:extLst>
            </p:cNvPr>
            <p:cNvSpPr/>
            <p:nvPr/>
          </p:nvSpPr>
          <p:spPr bwMode="auto">
            <a:xfrm>
              <a:off x="1219200" y="1905000"/>
              <a:ext cx="533400" cy="152400"/>
            </a:xfrm>
            <a:prstGeom prst="ellips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A0E9863B-1689-4C61-AF83-F656F1A66C11}"/>
                </a:ext>
              </a:extLst>
            </p:cNvPr>
            <p:cNvSpPr/>
            <p:nvPr/>
          </p:nvSpPr>
          <p:spPr bwMode="auto">
            <a:xfrm>
              <a:off x="1219200" y="1967917"/>
              <a:ext cx="533400" cy="152400"/>
            </a:xfrm>
            <a:prstGeom prst="ellipse">
              <a:avLst/>
            </a:prstGeom>
            <a:solidFill>
              <a:srgbClr val="FF0000">
                <a:alpha val="49020"/>
              </a:srgb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65D04801-2913-4553-8F77-9AD9639B9EF8}"/>
                </a:ext>
              </a:extLst>
            </p:cNvPr>
            <p:cNvCxnSpPr>
              <a:cxnSpLocks/>
              <a:stCxn id="63" idx="2"/>
              <a:endCxn id="62" idx="2"/>
            </p:cNvCxnSpPr>
            <p:nvPr/>
          </p:nvCxnSpPr>
          <p:spPr bwMode="auto">
            <a:xfrm flipV="1">
              <a:off x="12192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97105792-778C-4DD0-B542-6F033B12C3C3}"/>
                </a:ext>
              </a:extLst>
            </p:cNvPr>
            <p:cNvCxnSpPr>
              <a:cxnSpLocks/>
              <a:stCxn id="63" idx="6"/>
              <a:endCxn id="62" idx="6"/>
            </p:cNvCxnSpPr>
            <p:nvPr/>
          </p:nvCxnSpPr>
          <p:spPr bwMode="auto">
            <a:xfrm flipV="1">
              <a:off x="17526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FE60A16A-B4B6-4782-9534-4EDA0C282FF1}"/>
              </a:ext>
            </a:extLst>
          </p:cNvPr>
          <p:cNvGrpSpPr/>
          <p:nvPr/>
        </p:nvGrpSpPr>
        <p:grpSpPr>
          <a:xfrm>
            <a:off x="2132522" y="3163495"/>
            <a:ext cx="671336" cy="383425"/>
            <a:chOff x="1219200" y="1905000"/>
            <a:chExt cx="533400" cy="215317"/>
          </a:xfrm>
        </p:grpSpPr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6399625D-29D6-490B-BAF0-F32E7D8755D4}"/>
                </a:ext>
              </a:extLst>
            </p:cNvPr>
            <p:cNvSpPr/>
            <p:nvPr/>
          </p:nvSpPr>
          <p:spPr bwMode="auto">
            <a:xfrm>
              <a:off x="1219200" y="1905000"/>
              <a:ext cx="533400" cy="152400"/>
            </a:xfrm>
            <a:prstGeom prst="ellips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59" name="Oval 58">
              <a:extLst>
                <a:ext uri="{FF2B5EF4-FFF2-40B4-BE49-F238E27FC236}">
                  <a16:creationId xmlns:a16="http://schemas.microsoft.com/office/drawing/2014/main" id="{A8227076-A642-45D3-9FFE-FA26C71CF832}"/>
                </a:ext>
              </a:extLst>
            </p:cNvPr>
            <p:cNvSpPr/>
            <p:nvPr/>
          </p:nvSpPr>
          <p:spPr bwMode="auto">
            <a:xfrm>
              <a:off x="1219200" y="1967917"/>
              <a:ext cx="533400" cy="152400"/>
            </a:xfrm>
            <a:prstGeom prst="ellipse">
              <a:avLst/>
            </a:prstGeom>
            <a:solidFill>
              <a:srgbClr val="FF7453">
                <a:alpha val="49020"/>
              </a:srgb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3257E37A-2EC5-4186-90E3-40878237C691}"/>
                </a:ext>
              </a:extLst>
            </p:cNvPr>
            <p:cNvCxnSpPr>
              <a:cxnSpLocks/>
              <a:stCxn id="59" idx="2"/>
              <a:endCxn id="58" idx="2"/>
            </p:cNvCxnSpPr>
            <p:nvPr/>
          </p:nvCxnSpPr>
          <p:spPr bwMode="auto">
            <a:xfrm flipV="1">
              <a:off x="12192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1CA4DD66-F40D-449C-B94C-0E7E583F412F}"/>
                </a:ext>
              </a:extLst>
            </p:cNvPr>
            <p:cNvCxnSpPr>
              <a:cxnSpLocks/>
              <a:stCxn id="59" idx="6"/>
              <a:endCxn id="58" idx="6"/>
            </p:cNvCxnSpPr>
            <p:nvPr/>
          </p:nvCxnSpPr>
          <p:spPr bwMode="auto">
            <a:xfrm flipV="1">
              <a:off x="17526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1DC31522-B0C6-4E13-8768-1A762A0A9142}"/>
              </a:ext>
            </a:extLst>
          </p:cNvPr>
          <p:cNvGrpSpPr/>
          <p:nvPr/>
        </p:nvGrpSpPr>
        <p:grpSpPr>
          <a:xfrm>
            <a:off x="4837309" y="3038046"/>
            <a:ext cx="335668" cy="766848"/>
            <a:chOff x="5257800" y="1600200"/>
            <a:chExt cx="514352" cy="838200"/>
          </a:xfrm>
        </p:grpSpPr>
        <p:sp>
          <p:nvSpPr>
            <p:cNvPr id="53" name="Isosceles Triangle 52">
              <a:extLst>
                <a:ext uri="{FF2B5EF4-FFF2-40B4-BE49-F238E27FC236}">
                  <a16:creationId xmlns:a16="http://schemas.microsoft.com/office/drawing/2014/main" id="{ACF7CED4-7E83-4981-B014-9B365291F9AB}"/>
                </a:ext>
              </a:extLst>
            </p:cNvPr>
            <p:cNvSpPr/>
            <p:nvPr/>
          </p:nvSpPr>
          <p:spPr bwMode="auto">
            <a:xfrm rot="10800000">
              <a:off x="5257800" y="2133600"/>
              <a:ext cx="381000" cy="304800"/>
            </a:xfrm>
            <a:prstGeom prst="triangle">
              <a:avLst/>
            </a:prstGeom>
            <a:solidFill>
              <a:srgbClr val="FFCC99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rgbClr val="FFCC99"/>
                </a:solidFill>
                <a:effectLst/>
                <a:latin typeface="Arial" charset="0"/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58B683ED-6563-4CF5-83C2-D9DFE70D0EA0}"/>
                </a:ext>
              </a:extLst>
            </p:cNvPr>
            <p:cNvSpPr/>
            <p:nvPr/>
          </p:nvSpPr>
          <p:spPr bwMode="auto">
            <a:xfrm>
              <a:off x="5257801" y="1663914"/>
              <a:ext cx="381000" cy="469686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B386AA69-CF62-4879-A1DD-89C0ADE6C63F}"/>
                </a:ext>
              </a:extLst>
            </p:cNvPr>
            <p:cNvSpPr/>
            <p:nvPr/>
          </p:nvSpPr>
          <p:spPr bwMode="auto">
            <a:xfrm>
              <a:off x="5257800" y="1600200"/>
              <a:ext cx="514352" cy="63714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8C902E2D-5B14-4E49-BA21-F7B2A69A3B47}"/>
                </a:ext>
              </a:extLst>
            </p:cNvPr>
            <p:cNvCxnSpPr/>
            <p:nvPr/>
          </p:nvCxnSpPr>
          <p:spPr bwMode="auto">
            <a:xfrm>
              <a:off x="5257800" y="17717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71AE45A7-8419-4DA1-97F1-E68664786448}"/>
                </a:ext>
              </a:extLst>
            </p:cNvPr>
            <p:cNvCxnSpPr/>
            <p:nvPr/>
          </p:nvCxnSpPr>
          <p:spPr bwMode="auto">
            <a:xfrm>
              <a:off x="5257800" y="19241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9F8C2FBD-A786-414F-840C-04476DBE84D3}"/>
              </a:ext>
            </a:extLst>
          </p:cNvPr>
          <p:cNvGrpSpPr/>
          <p:nvPr/>
        </p:nvGrpSpPr>
        <p:grpSpPr>
          <a:xfrm>
            <a:off x="5877648" y="3035176"/>
            <a:ext cx="335668" cy="766848"/>
            <a:chOff x="5257800" y="1600200"/>
            <a:chExt cx="514352" cy="838200"/>
          </a:xfrm>
        </p:grpSpPr>
        <p:sp>
          <p:nvSpPr>
            <p:cNvPr id="48" name="Isosceles Triangle 47">
              <a:extLst>
                <a:ext uri="{FF2B5EF4-FFF2-40B4-BE49-F238E27FC236}">
                  <a16:creationId xmlns:a16="http://schemas.microsoft.com/office/drawing/2014/main" id="{A6DF6804-079C-488C-9BCD-6A771DB06982}"/>
                </a:ext>
              </a:extLst>
            </p:cNvPr>
            <p:cNvSpPr/>
            <p:nvPr/>
          </p:nvSpPr>
          <p:spPr bwMode="auto">
            <a:xfrm rot="10800000">
              <a:off x="5257800" y="2133600"/>
              <a:ext cx="381000" cy="304800"/>
            </a:xfrm>
            <a:prstGeom prst="triangle">
              <a:avLst/>
            </a:prstGeom>
            <a:solidFill>
              <a:srgbClr val="FFF3E7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F6EA395E-1C6B-41A0-B6C0-2E1DE28C8658}"/>
                </a:ext>
              </a:extLst>
            </p:cNvPr>
            <p:cNvSpPr/>
            <p:nvPr/>
          </p:nvSpPr>
          <p:spPr bwMode="auto">
            <a:xfrm>
              <a:off x="5257801" y="1663914"/>
              <a:ext cx="381000" cy="469686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5997E9E9-D10E-468A-A74A-462DC300FEF8}"/>
                </a:ext>
              </a:extLst>
            </p:cNvPr>
            <p:cNvSpPr/>
            <p:nvPr/>
          </p:nvSpPr>
          <p:spPr bwMode="auto">
            <a:xfrm>
              <a:off x="5257800" y="1600200"/>
              <a:ext cx="514352" cy="63714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EB7F650E-FFE0-42E0-A570-3BEF82577E09}"/>
                </a:ext>
              </a:extLst>
            </p:cNvPr>
            <p:cNvCxnSpPr/>
            <p:nvPr/>
          </p:nvCxnSpPr>
          <p:spPr bwMode="auto">
            <a:xfrm>
              <a:off x="5257800" y="17717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43F53444-80EB-4D87-9DFD-B0A72AED27C9}"/>
                </a:ext>
              </a:extLst>
            </p:cNvPr>
            <p:cNvCxnSpPr/>
            <p:nvPr/>
          </p:nvCxnSpPr>
          <p:spPr bwMode="auto">
            <a:xfrm>
              <a:off x="5257800" y="19241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4B18150-37FF-4E9C-9757-99CB665CFE02}"/>
              </a:ext>
            </a:extLst>
          </p:cNvPr>
          <p:cNvCxnSpPr>
            <a:cxnSpLocks/>
          </p:cNvCxnSpPr>
          <p:nvPr/>
        </p:nvCxnSpPr>
        <p:spPr bwMode="auto">
          <a:xfrm>
            <a:off x="1653495" y="3355207"/>
            <a:ext cx="335668" cy="0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15B0784-A99E-42BA-8CF5-672236837204}"/>
              </a:ext>
            </a:extLst>
          </p:cNvPr>
          <p:cNvCxnSpPr>
            <a:cxnSpLocks/>
          </p:cNvCxnSpPr>
          <p:nvPr/>
        </p:nvCxnSpPr>
        <p:spPr bwMode="auto">
          <a:xfrm>
            <a:off x="4174294" y="3344978"/>
            <a:ext cx="335668" cy="0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7C0D079-8BFE-40A7-8529-07D975C80173}"/>
              </a:ext>
            </a:extLst>
          </p:cNvPr>
          <p:cNvCxnSpPr>
            <a:cxnSpLocks/>
          </p:cNvCxnSpPr>
          <p:nvPr/>
        </p:nvCxnSpPr>
        <p:spPr bwMode="auto">
          <a:xfrm>
            <a:off x="5342559" y="3331580"/>
            <a:ext cx="335668" cy="0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2" name="TextBox 28">
            <a:extLst>
              <a:ext uri="{FF2B5EF4-FFF2-40B4-BE49-F238E27FC236}">
                <a16:creationId xmlns:a16="http://schemas.microsoft.com/office/drawing/2014/main" id="{98065ACB-8DC6-4CE1-A3F1-7D9F004BFBBB}"/>
              </a:ext>
            </a:extLst>
          </p:cNvPr>
          <p:cNvSpPr txBox="1"/>
          <p:nvPr/>
        </p:nvSpPr>
        <p:spPr>
          <a:xfrm>
            <a:off x="2060880" y="2797678"/>
            <a:ext cx="855745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/>
              <a:t>R6K6</a:t>
            </a:r>
          </a:p>
        </p:txBody>
      </p:sp>
      <p:sp>
        <p:nvSpPr>
          <p:cNvPr id="13" name="TextBox 29">
            <a:extLst>
              <a:ext uri="{FF2B5EF4-FFF2-40B4-BE49-F238E27FC236}">
                <a16:creationId xmlns:a16="http://schemas.microsoft.com/office/drawing/2014/main" id="{C912E45E-4AEC-4DC7-9628-98B901E168B6}"/>
              </a:ext>
            </a:extLst>
          </p:cNvPr>
          <p:cNvSpPr txBox="1"/>
          <p:nvPr/>
        </p:nvSpPr>
        <p:spPr>
          <a:xfrm>
            <a:off x="2822710" y="3467126"/>
            <a:ext cx="855745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Chase</a:t>
            </a:r>
          </a:p>
        </p:txBody>
      </p:sp>
      <p:sp>
        <p:nvSpPr>
          <p:cNvPr id="14" name="TextBox 30">
            <a:extLst>
              <a:ext uri="{FF2B5EF4-FFF2-40B4-BE49-F238E27FC236}">
                <a16:creationId xmlns:a16="http://schemas.microsoft.com/office/drawing/2014/main" id="{427C01DE-3108-4DA7-B4FB-B577F18F88F1}"/>
              </a:ext>
            </a:extLst>
          </p:cNvPr>
          <p:cNvSpPr txBox="1"/>
          <p:nvPr/>
        </p:nvSpPr>
        <p:spPr>
          <a:xfrm>
            <a:off x="1475228" y="3467126"/>
            <a:ext cx="855745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Pulse</a:t>
            </a:r>
          </a:p>
        </p:txBody>
      </p:sp>
      <p:sp>
        <p:nvSpPr>
          <p:cNvPr id="15" name="TextBox 31">
            <a:extLst>
              <a:ext uri="{FF2B5EF4-FFF2-40B4-BE49-F238E27FC236}">
                <a16:creationId xmlns:a16="http://schemas.microsoft.com/office/drawing/2014/main" id="{CBA2A9C3-0AF3-49DC-8252-2AE3C73BE403}"/>
              </a:ext>
            </a:extLst>
          </p:cNvPr>
          <p:cNvSpPr txBox="1"/>
          <p:nvPr/>
        </p:nvSpPr>
        <p:spPr>
          <a:xfrm>
            <a:off x="6162142" y="3508152"/>
            <a:ext cx="1094280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Pull down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6B048A1-2428-4B32-BCF3-0470B3669823}"/>
              </a:ext>
            </a:extLst>
          </p:cNvPr>
          <p:cNvGrpSpPr/>
          <p:nvPr/>
        </p:nvGrpSpPr>
        <p:grpSpPr>
          <a:xfrm>
            <a:off x="7003212" y="3030085"/>
            <a:ext cx="335668" cy="766848"/>
            <a:chOff x="5257800" y="1600200"/>
            <a:chExt cx="514352" cy="838200"/>
          </a:xfrm>
        </p:grpSpPr>
        <p:sp>
          <p:nvSpPr>
            <p:cNvPr id="43" name="Isosceles Triangle 42">
              <a:extLst>
                <a:ext uri="{FF2B5EF4-FFF2-40B4-BE49-F238E27FC236}">
                  <a16:creationId xmlns:a16="http://schemas.microsoft.com/office/drawing/2014/main" id="{ED25F676-A5B3-4CCC-8718-FB79D696D867}"/>
                </a:ext>
              </a:extLst>
            </p:cNvPr>
            <p:cNvSpPr/>
            <p:nvPr/>
          </p:nvSpPr>
          <p:spPr bwMode="auto">
            <a:xfrm rot="10800000">
              <a:off x="5257800" y="2133600"/>
              <a:ext cx="381000" cy="304800"/>
            </a:xfrm>
            <a:prstGeom prst="triangle">
              <a:avLst/>
            </a:prstGeom>
            <a:solidFill>
              <a:srgbClr val="FFF3E7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B6E4C151-B73D-407B-BC5C-9285B46DC6FF}"/>
                </a:ext>
              </a:extLst>
            </p:cNvPr>
            <p:cNvSpPr/>
            <p:nvPr/>
          </p:nvSpPr>
          <p:spPr bwMode="auto">
            <a:xfrm>
              <a:off x="5257801" y="1663914"/>
              <a:ext cx="381000" cy="469686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B9C5755B-3C73-45D7-944A-8FA269E2C667}"/>
                </a:ext>
              </a:extLst>
            </p:cNvPr>
            <p:cNvSpPr/>
            <p:nvPr/>
          </p:nvSpPr>
          <p:spPr bwMode="auto">
            <a:xfrm>
              <a:off x="5257800" y="1600200"/>
              <a:ext cx="514352" cy="63714"/>
            </a:xfrm>
            <a:prstGeom prst="rect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DED3EC4D-65BF-4E9B-8F34-5BD663516603}"/>
                </a:ext>
              </a:extLst>
            </p:cNvPr>
            <p:cNvCxnSpPr/>
            <p:nvPr/>
          </p:nvCxnSpPr>
          <p:spPr bwMode="auto">
            <a:xfrm>
              <a:off x="5257800" y="17717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334B7B39-77CD-4A8E-A139-6EF11E3AE768}"/>
                </a:ext>
              </a:extLst>
            </p:cNvPr>
            <p:cNvCxnSpPr/>
            <p:nvPr/>
          </p:nvCxnSpPr>
          <p:spPr bwMode="auto">
            <a:xfrm>
              <a:off x="5257800" y="1924182"/>
              <a:ext cx="152400" cy="0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3F783360-7442-4770-8480-5C45E0658956}"/>
              </a:ext>
            </a:extLst>
          </p:cNvPr>
          <p:cNvCxnSpPr>
            <a:cxnSpLocks/>
          </p:cNvCxnSpPr>
          <p:nvPr/>
        </p:nvCxnSpPr>
        <p:spPr bwMode="auto">
          <a:xfrm>
            <a:off x="6310701" y="3331580"/>
            <a:ext cx="458445" cy="0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8" name="TextBox 34">
            <a:extLst>
              <a:ext uri="{FF2B5EF4-FFF2-40B4-BE49-F238E27FC236}">
                <a16:creationId xmlns:a16="http://schemas.microsoft.com/office/drawing/2014/main" id="{E22234A8-A7D3-4F49-BE3C-A241868E9420}"/>
              </a:ext>
            </a:extLst>
          </p:cNvPr>
          <p:cNvSpPr txBox="1"/>
          <p:nvPr/>
        </p:nvSpPr>
        <p:spPr>
          <a:xfrm>
            <a:off x="5246177" y="3474616"/>
            <a:ext cx="1094280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lyse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D0346A7-3770-44F4-86A3-7B2FE00CF733}"/>
              </a:ext>
            </a:extLst>
          </p:cNvPr>
          <p:cNvGrpSpPr/>
          <p:nvPr/>
        </p:nvGrpSpPr>
        <p:grpSpPr>
          <a:xfrm>
            <a:off x="3404653" y="3145028"/>
            <a:ext cx="671336" cy="383425"/>
            <a:chOff x="1219200" y="1905000"/>
            <a:chExt cx="533400" cy="215317"/>
          </a:xfrm>
        </p:grpSpPr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5BFFB0C4-9DD6-4E0B-9AB3-509530893F4B}"/>
                </a:ext>
              </a:extLst>
            </p:cNvPr>
            <p:cNvSpPr/>
            <p:nvPr/>
          </p:nvSpPr>
          <p:spPr bwMode="auto">
            <a:xfrm>
              <a:off x="1219200" y="1905000"/>
              <a:ext cx="533400" cy="152400"/>
            </a:xfrm>
            <a:prstGeom prst="ellips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1E652B74-D813-4609-A11B-8C13B93E4A9D}"/>
                </a:ext>
              </a:extLst>
            </p:cNvPr>
            <p:cNvSpPr/>
            <p:nvPr/>
          </p:nvSpPr>
          <p:spPr bwMode="auto">
            <a:xfrm>
              <a:off x="1219200" y="1967917"/>
              <a:ext cx="533400" cy="152400"/>
            </a:xfrm>
            <a:prstGeom prst="ellipse">
              <a:avLst/>
            </a:prstGeom>
            <a:solidFill>
              <a:srgbClr val="FF0000">
                <a:alpha val="49020"/>
              </a:srgbClr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E6B07BCF-81A5-444B-97C6-A28E3BE3EE23}"/>
                </a:ext>
              </a:extLst>
            </p:cNvPr>
            <p:cNvCxnSpPr>
              <a:cxnSpLocks/>
              <a:stCxn id="40" idx="2"/>
              <a:endCxn id="39" idx="2"/>
            </p:cNvCxnSpPr>
            <p:nvPr/>
          </p:nvCxnSpPr>
          <p:spPr bwMode="auto">
            <a:xfrm flipV="1">
              <a:off x="12192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98183E80-6A41-4E91-B5C6-1895BFB5A322}"/>
                </a:ext>
              </a:extLst>
            </p:cNvPr>
            <p:cNvCxnSpPr>
              <a:cxnSpLocks/>
              <a:stCxn id="40" idx="6"/>
              <a:endCxn id="39" idx="6"/>
            </p:cNvCxnSpPr>
            <p:nvPr/>
          </p:nvCxnSpPr>
          <p:spPr bwMode="auto">
            <a:xfrm flipV="1">
              <a:off x="1752600" y="1981200"/>
              <a:ext cx="0" cy="62917"/>
            </a:xfrm>
            <a:prstGeom prst="line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</p:grp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EFAE19B-31AD-4DD3-A0B0-B15CF4FA3187}"/>
              </a:ext>
            </a:extLst>
          </p:cNvPr>
          <p:cNvCxnSpPr>
            <a:cxnSpLocks/>
          </p:cNvCxnSpPr>
          <p:nvPr/>
        </p:nvCxnSpPr>
        <p:spPr bwMode="auto">
          <a:xfrm>
            <a:off x="2916625" y="3336740"/>
            <a:ext cx="335668" cy="0"/>
          </a:xfrm>
          <a:prstGeom prst="straightConnector1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21" name="TextBox 37">
            <a:extLst>
              <a:ext uri="{FF2B5EF4-FFF2-40B4-BE49-F238E27FC236}">
                <a16:creationId xmlns:a16="http://schemas.microsoft.com/office/drawing/2014/main" id="{2755776B-849A-4CB5-950B-D0460E5535DF}"/>
              </a:ext>
            </a:extLst>
          </p:cNvPr>
          <p:cNvSpPr txBox="1"/>
          <p:nvPr/>
        </p:nvSpPr>
        <p:spPr>
          <a:xfrm>
            <a:off x="4021608" y="3474615"/>
            <a:ext cx="855745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/>
              <a:t>harvest</a:t>
            </a:r>
          </a:p>
        </p:txBody>
      </p:sp>
      <p:sp>
        <p:nvSpPr>
          <p:cNvPr id="22" name="TextBox 38">
            <a:extLst>
              <a:ext uri="{FF2B5EF4-FFF2-40B4-BE49-F238E27FC236}">
                <a16:creationId xmlns:a16="http://schemas.microsoft.com/office/drawing/2014/main" id="{B678AC0D-0BE1-4EB6-97F4-46C605EDE313}"/>
              </a:ext>
            </a:extLst>
          </p:cNvPr>
          <p:cNvSpPr txBox="1"/>
          <p:nvPr/>
        </p:nvSpPr>
        <p:spPr>
          <a:xfrm>
            <a:off x="3289853" y="2772924"/>
            <a:ext cx="855745" cy="348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/>
              <a:t>R0K0</a:t>
            </a:r>
          </a:p>
        </p:txBody>
      </p:sp>
      <p:sp>
        <p:nvSpPr>
          <p:cNvPr id="23" name="TextBox 71">
            <a:extLst>
              <a:ext uri="{FF2B5EF4-FFF2-40B4-BE49-F238E27FC236}">
                <a16:creationId xmlns:a16="http://schemas.microsoft.com/office/drawing/2014/main" id="{3E1BC46C-F48F-43CC-83C4-16620BF55832}"/>
              </a:ext>
            </a:extLst>
          </p:cNvPr>
          <p:cNvSpPr txBox="1"/>
          <p:nvPr/>
        </p:nvSpPr>
        <p:spPr>
          <a:xfrm>
            <a:off x="436924" y="2412782"/>
            <a:ext cx="28136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Transfected HEK293T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>
                <a:solidFill>
                  <a:srgbClr val="000000"/>
                </a:solidFill>
                <a:latin typeface="Arial"/>
              </a:rPr>
              <a:t>PD-L1 3xFlag</a:t>
            </a: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E89D9F2D-A4FE-4D4F-8E9D-3D22DECFE6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748" r="82219" b="34838"/>
          <a:stretch/>
        </p:blipFill>
        <p:spPr bwMode="auto">
          <a:xfrm>
            <a:off x="7855857" y="2856315"/>
            <a:ext cx="978862" cy="1323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E23FB73-C2EF-4DD3-A038-343E37FD91A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219" t="26749" b="34838"/>
          <a:stretch/>
        </p:blipFill>
        <p:spPr bwMode="auto">
          <a:xfrm>
            <a:off x="9099329" y="2811043"/>
            <a:ext cx="1014776" cy="1372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30A09BD-60AA-4931-925B-ECEBFEDC352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19" t="67399" r="40535" b="-31"/>
          <a:stretch/>
        </p:blipFill>
        <p:spPr bwMode="auto">
          <a:xfrm>
            <a:off x="10396570" y="2885442"/>
            <a:ext cx="1214665" cy="1130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75">
            <a:extLst>
              <a:ext uri="{FF2B5EF4-FFF2-40B4-BE49-F238E27FC236}">
                <a16:creationId xmlns:a16="http://schemas.microsoft.com/office/drawing/2014/main" id="{EAFAE978-1E1B-4121-817F-6A9BAA2FBCCD}"/>
              </a:ext>
            </a:extLst>
          </p:cNvPr>
          <p:cNvSpPr txBox="1"/>
          <p:nvPr/>
        </p:nvSpPr>
        <p:spPr>
          <a:xfrm>
            <a:off x="7842888" y="2547880"/>
            <a:ext cx="1371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R0K0</a:t>
            </a:r>
          </a:p>
        </p:txBody>
      </p:sp>
      <p:sp>
        <p:nvSpPr>
          <p:cNvPr id="28" name="TextBox 76">
            <a:extLst>
              <a:ext uri="{FF2B5EF4-FFF2-40B4-BE49-F238E27FC236}">
                <a16:creationId xmlns:a16="http://schemas.microsoft.com/office/drawing/2014/main" id="{61013A1D-3A55-40DB-9BA7-8B8C73052F17}"/>
              </a:ext>
            </a:extLst>
          </p:cNvPr>
          <p:cNvSpPr txBox="1"/>
          <p:nvPr/>
        </p:nvSpPr>
        <p:spPr>
          <a:xfrm>
            <a:off x="9181660" y="2544784"/>
            <a:ext cx="1371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+mn-ea"/>
                <a:cs typeface="+mn-cs"/>
              </a:rPr>
              <a:t>R6K6</a:t>
            </a:r>
          </a:p>
        </p:txBody>
      </p:sp>
      <p:sp>
        <p:nvSpPr>
          <p:cNvPr id="29" name="TextBox 69">
            <a:extLst>
              <a:ext uri="{FF2B5EF4-FFF2-40B4-BE49-F238E27FC236}">
                <a16:creationId xmlns:a16="http://schemas.microsoft.com/office/drawing/2014/main" id="{A62B7C56-C22F-4F8D-90B0-D99461996809}"/>
              </a:ext>
            </a:extLst>
          </p:cNvPr>
          <p:cNvSpPr txBox="1"/>
          <p:nvPr/>
        </p:nvSpPr>
        <p:spPr>
          <a:xfrm>
            <a:off x="7886260" y="4614990"/>
            <a:ext cx="19812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/>
              <a:t>Light(R0K0) </a:t>
            </a:r>
            <a:r>
              <a:rPr lang="en-US"/>
              <a:t>– mixed population of protein</a:t>
            </a:r>
          </a:p>
          <a:p>
            <a:r>
              <a:rPr lang="en-US" b="1">
                <a:solidFill>
                  <a:srgbClr val="FF0000"/>
                </a:solidFill>
              </a:rPr>
              <a:t>Heavy(R6K6) </a:t>
            </a:r>
            <a:r>
              <a:rPr lang="en-US"/>
              <a:t>– protein synthesized during pulse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C4CC7497-3975-4702-8FA6-7C4C21FCDD11}"/>
              </a:ext>
            </a:extLst>
          </p:cNvPr>
          <p:cNvGrpSpPr/>
          <p:nvPr/>
        </p:nvGrpSpPr>
        <p:grpSpPr>
          <a:xfrm>
            <a:off x="941313" y="3808044"/>
            <a:ext cx="6466346" cy="2838271"/>
            <a:chOff x="919377" y="3253789"/>
            <a:chExt cx="6466346" cy="2838271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9ECCCDB-832E-4303-8059-9EF9A2CFD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70769" y="3776493"/>
              <a:ext cx="6363177" cy="2315567"/>
            </a:xfrm>
            <a:prstGeom prst="rect">
              <a:avLst/>
            </a:prstGeom>
          </p:spPr>
        </p:pic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39E60CC-B0AC-440D-9B47-0FE821D0F61A}"/>
                </a:ext>
              </a:extLst>
            </p:cNvPr>
            <p:cNvGrpSpPr/>
            <p:nvPr/>
          </p:nvGrpSpPr>
          <p:grpSpPr>
            <a:xfrm>
              <a:off x="919377" y="3253789"/>
              <a:ext cx="6466346" cy="2838271"/>
              <a:chOff x="919377" y="3253789"/>
              <a:chExt cx="6466346" cy="2838271"/>
            </a:xfrm>
          </p:grpSpPr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31656C7B-A166-4D93-A654-07944E54D3F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19377" y="3261323"/>
                <a:ext cx="2298384" cy="364971"/>
              </a:xfrm>
              <a:prstGeom prst="line">
                <a:avLst/>
              </a:prstGeom>
              <a:ln w="28575"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0F4E87E2-A833-4101-B357-6475AFF965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18375" y="3253789"/>
                <a:ext cx="4166119" cy="381889"/>
              </a:xfrm>
              <a:prstGeom prst="line">
                <a:avLst/>
              </a:prstGeom>
              <a:ln w="28575"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014B37B6-20DF-4E20-8B2F-7C830CB7CA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1333" y="3625589"/>
                <a:ext cx="0" cy="2466471"/>
              </a:xfrm>
              <a:prstGeom prst="line">
                <a:avLst/>
              </a:prstGeom>
              <a:ln w="28575"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08F2EE42-C634-4538-8FB6-8B453A9EC3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5108" y="3625589"/>
                <a:ext cx="0" cy="2466471"/>
              </a:xfrm>
              <a:prstGeom prst="line">
                <a:avLst/>
              </a:prstGeom>
              <a:ln w="28575"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A48487C9-A319-44AE-8892-A41C8A7B9C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4738" y="6092060"/>
                <a:ext cx="6450985" cy="0"/>
              </a:xfrm>
              <a:prstGeom prst="line">
                <a:avLst/>
              </a:prstGeom>
              <a:ln w="28575">
                <a:solidFill>
                  <a:schemeClr val="tx2">
                    <a:lumMod val="20000"/>
                    <a:lumOff val="8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1" name="Content Placeholder 2">
            <a:extLst>
              <a:ext uri="{FF2B5EF4-FFF2-40B4-BE49-F238E27FC236}">
                <a16:creationId xmlns:a16="http://schemas.microsoft.com/office/drawing/2014/main" id="{3CD05221-19E2-4990-8790-8B38B68F9FFD}"/>
              </a:ext>
            </a:extLst>
          </p:cNvPr>
          <p:cNvSpPr txBox="1">
            <a:spLocks/>
          </p:cNvSpPr>
          <p:nvPr/>
        </p:nvSpPr>
        <p:spPr>
          <a:xfrm>
            <a:off x="1899051" y="2017536"/>
            <a:ext cx="8482167" cy="476250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>
                <a:solidFill>
                  <a:schemeClr val="tx2"/>
                </a:solidFill>
              </a:rPr>
              <a:t>Uses naturally occurring isotopic differences in H, C, N atoms for labeling (Arginine R, Lysine K)</a:t>
            </a:r>
          </a:p>
        </p:txBody>
      </p:sp>
    </p:spTree>
    <p:extLst>
      <p:ext uri="{BB962C8B-B14F-4D97-AF65-F5344CB8AC3E}">
        <p14:creationId xmlns:p14="http://schemas.microsoft.com/office/powerpoint/2010/main" val="1792874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5361B-CD0A-57B9-BC98-47E421A5ED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estern Blot Process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7FACF0-8A10-B8DC-E1FE-F2ADA0331B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90575" y="1615440"/>
            <a:ext cx="10515600" cy="4351338"/>
          </a:xfrm>
        </p:spPr>
        <p:txBody>
          <a:bodyPr>
            <a:normAutofit fontScale="77500" lnSpcReduction="20000"/>
          </a:bodyPr>
          <a:lstStyle/>
          <a:p>
            <a:r>
              <a:rPr lang="en-US"/>
              <a:t>Transfer using iBlot2 imager with 7 min protocol. </a:t>
            </a:r>
          </a:p>
          <a:p>
            <a:r>
              <a:rPr lang="en-US"/>
              <a:t>Block with 5% milk in 1X TBST 30 min at RT. </a:t>
            </a:r>
          </a:p>
          <a:p>
            <a:r>
              <a:rPr lang="en-US"/>
              <a:t>Incubation with appropriate antibody (see methods)</a:t>
            </a:r>
            <a:r>
              <a:rPr lang="zh-CN" altLang="en-US"/>
              <a:t> </a:t>
            </a:r>
            <a:r>
              <a:rPr lang="en-US" altLang="zh-CN"/>
              <a:t>in</a:t>
            </a:r>
            <a:r>
              <a:rPr lang="zh-CN" altLang="en-US"/>
              <a:t> </a:t>
            </a:r>
            <a:r>
              <a:rPr lang="en-US" altLang="zh-CN"/>
              <a:t>TBST</a:t>
            </a:r>
            <a:r>
              <a:rPr lang="zh-CN" altLang="en-US"/>
              <a:t> </a:t>
            </a:r>
            <a:r>
              <a:rPr lang="en-US" altLang="zh-CN"/>
              <a:t>overnight at 4C </a:t>
            </a:r>
          </a:p>
          <a:p>
            <a:r>
              <a:rPr lang="en-US"/>
              <a:t>Washed 3x with 1X TBST for 5 min </a:t>
            </a:r>
          </a:p>
          <a:p>
            <a:r>
              <a:rPr lang="en-US"/>
              <a:t>Used ECL reagent according to manufacturer’s protocol (Pierce ECL kit) </a:t>
            </a:r>
          </a:p>
          <a:p>
            <a:r>
              <a:rPr lang="en-US"/>
              <a:t>Western Blot images were acquired on the GE </a:t>
            </a:r>
            <a:r>
              <a:rPr lang="en-US" err="1"/>
              <a:t>ImageQuant</a:t>
            </a:r>
            <a:r>
              <a:rPr lang="en-US"/>
              <a:t> LAS4000 using default </a:t>
            </a:r>
            <a:r>
              <a:rPr lang="en-US" err="1"/>
              <a:t>Fluoresence</a:t>
            </a:r>
            <a:r>
              <a:rPr lang="en-US"/>
              <a:t> settings ( Cy2 channel, Blue light (Epi-RGB), Y515 Di filter and the Iris set to F0.85)</a:t>
            </a:r>
          </a:p>
          <a:p>
            <a:r>
              <a:rPr lang="en-US">
                <a:solidFill>
                  <a:schemeClr val="accent1">
                    <a:lumMod val="75000"/>
                  </a:schemeClr>
                </a:solidFill>
              </a:rPr>
              <a:t>Imaged blots using auto detect setting to prevent oversaturation.  No overexposed blots included.</a:t>
            </a:r>
          </a:p>
          <a:p>
            <a:r>
              <a:rPr lang="en-US">
                <a:solidFill>
                  <a:srgbClr val="FF0000"/>
                </a:solidFill>
              </a:rPr>
              <a:t>Blots cropped in the manuscript for organization and clarity only; no additional manipulation performed</a:t>
            </a:r>
          </a:p>
          <a:p>
            <a:r>
              <a:rPr lang="en-US">
                <a:solidFill>
                  <a:srgbClr val="FF0000"/>
                </a:solidFill>
              </a:rPr>
              <a:t>Uncropped images for all WB in the following pages</a:t>
            </a:r>
          </a:p>
        </p:txBody>
      </p:sp>
    </p:spTree>
    <p:extLst>
      <p:ext uri="{BB962C8B-B14F-4D97-AF65-F5344CB8AC3E}">
        <p14:creationId xmlns:p14="http://schemas.microsoft.com/office/powerpoint/2010/main" val="127729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3" descr="\\apollo\temp\Mariya\20180712 total pdl1 chem.bmp">
            <a:extLst>
              <a:ext uri="{FF2B5EF4-FFF2-40B4-BE49-F238E27FC236}">
                <a16:creationId xmlns:a16="http://schemas.microsoft.com/office/drawing/2014/main" id="{FF550782-6C99-E23C-7077-D7FDA30AED9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87" t="2956" r="18993" b="-19384"/>
          <a:stretch/>
        </p:blipFill>
        <p:spPr bwMode="auto">
          <a:xfrm>
            <a:off x="2091393" y="2073354"/>
            <a:ext cx="3876981" cy="30977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C4A99BE7-2F96-8932-91D4-2CF93A5DA5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8ABCA34-F567-3626-6AAD-0F84E163A793}"/>
              </a:ext>
            </a:extLst>
          </p:cNvPr>
          <p:cNvSpPr txBox="1"/>
          <p:nvPr/>
        </p:nvSpPr>
        <p:spPr>
          <a:xfrm flipH="1">
            <a:off x="481507" y="5568764"/>
            <a:ext cx="108722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2B Uncropped Western Blots.  </a:t>
            </a:r>
          </a:p>
          <a:p>
            <a:r>
              <a:rPr lang="en-US" i="1" dirty="0"/>
              <a:t>Full membrane edges indicated by blue arrows.  Cropped edges indicated by red arrows.  Note that the </a:t>
            </a:r>
            <a:r>
              <a:rPr lang="en-US" i="1" u="sng" dirty="0"/>
              <a:t>actin</a:t>
            </a:r>
            <a:r>
              <a:rPr lang="en-US" i="1" dirty="0"/>
              <a:t> blot was read out by chemiluminescence instead of fluorescence, making the MW ladder (red arrow) not visible and the edges of the membrane of more subtle contrast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D6AEA84-846C-6842-EF2E-A85E8D64557C}"/>
              </a:ext>
            </a:extLst>
          </p:cNvPr>
          <p:cNvSpPr txBox="1"/>
          <p:nvPr/>
        </p:nvSpPr>
        <p:spPr>
          <a:xfrm>
            <a:off x="4042499" y="3206334"/>
            <a:ext cx="909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BMS-10034</a:t>
            </a:r>
            <a:endParaRPr lang="en-US" sz="1200" b="1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3925120-F97B-D9B7-189D-AF6F84329CCB}"/>
              </a:ext>
            </a:extLst>
          </p:cNvPr>
          <p:cNvSpPr txBox="1"/>
          <p:nvPr/>
        </p:nvSpPr>
        <p:spPr>
          <a:xfrm>
            <a:off x="2501963" y="4700279"/>
            <a:ext cx="9876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GS-4224</a:t>
            </a:r>
            <a:endParaRPr lang="en-US" sz="1200" b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2541C7D-9D3F-E1A6-5A87-909192048A81}"/>
              </a:ext>
            </a:extLst>
          </p:cNvPr>
          <p:cNvSpPr txBox="1"/>
          <p:nvPr/>
        </p:nvSpPr>
        <p:spPr>
          <a:xfrm>
            <a:off x="2745291" y="3278665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MSO</a:t>
            </a:r>
            <a:endParaRPr lang="en-US" sz="1200" b="1" dirty="0">
              <a:solidFill>
                <a:prstClr val="black"/>
              </a:solidFill>
              <a:latin typeface="Calibri"/>
            </a:endParaRPr>
          </a:p>
        </p:txBody>
      </p:sp>
      <p:pic>
        <p:nvPicPr>
          <p:cNvPr id="5" name="Picture 5" descr="Shape, rectangle&#10;&#10;Description automatically generated">
            <a:extLst>
              <a:ext uri="{FF2B5EF4-FFF2-40B4-BE49-F238E27FC236}">
                <a16:creationId xmlns:a16="http://schemas.microsoft.com/office/drawing/2014/main" id="{86199ED2-CA88-AF92-18B7-E21F2F1536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2730" y="1641189"/>
            <a:ext cx="3896668" cy="4018405"/>
          </a:xfrm>
          <a:prstGeom prst="rect">
            <a:avLst/>
          </a:prstGeom>
        </p:spPr>
      </p:pic>
      <p:sp>
        <p:nvSpPr>
          <p:cNvPr id="6" name="Right Brace 5">
            <a:extLst>
              <a:ext uri="{FF2B5EF4-FFF2-40B4-BE49-F238E27FC236}">
                <a16:creationId xmlns:a16="http://schemas.microsoft.com/office/drawing/2014/main" id="{2A7970AF-6840-7C53-5793-31231B421D66}"/>
              </a:ext>
            </a:extLst>
          </p:cNvPr>
          <p:cNvSpPr/>
          <p:nvPr/>
        </p:nvSpPr>
        <p:spPr>
          <a:xfrm rot="5400000">
            <a:off x="8979692" y="3324086"/>
            <a:ext cx="193342" cy="134202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021B00-6026-0CAA-B26C-5776B065C674}"/>
              </a:ext>
            </a:extLst>
          </p:cNvPr>
          <p:cNvSpPr txBox="1"/>
          <p:nvPr/>
        </p:nvSpPr>
        <p:spPr>
          <a:xfrm>
            <a:off x="8120255" y="4054817"/>
            <a:ext cx="2944646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cs typeface="Calibri"/>
              </a:rPr>
              <a:t>Relevant to Fig 2B</a:t>
            </a:r>
            <a:endParaRPr lang="en-US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648B98C-D510-5A82-FB4F-5BE2D035A093}"/>
              </a:ext>
            </a:extLst>
          </p:cNvPr>
          <p:cNvCxnSpPr>
            <a:cxnSpLocks/>
          </p:cNvCxnSpPr>
          <p:nvPr/>
        </p:nvCxnSpPr>
        <p:spPr>
          <a:xfrm>
            <a:off x="5285754" y="1781584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1B2D15A-56CF-98D4-E616-8504E2E3DD33}"/>
              </a:ext>
            </a:extLst>
          </p:cNvPr>
          <p:cNvCxnSpPr>
            <a:cxnSpLocks/>
          </p:cNvCxnSpPr>
          <p:nvPr/>
        </p:nvCxnSpPr>
        <p:spPr>
          <a:xfrm flipH="1">
            <a:off x="5285754" y="3553177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0F14DE8-ADCE-EBB2-BC33-899894EDAADF}"/>
              </a:ext>
            </a:extLst>
          </p:cNvPr>
          <p:cNvCxnSpPr>
            <a:cxnSpLocks/>
          </p:cNvCxnSpPr>
          <p:nvPr/>
        </p:nvCxnSpPr>
        <p:spPr>
          <a:xfrm>
            <a:off x="11047638" y="1921595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362774C-4BEB-5BE6-7E7C-415E2BF39C84}"/>
              </a:ext>
            </a:extLst>
          </p:cNvPr>
          <p:cNvCxnSpPr>
            <a:cxnSpLocks/>
          </p:cNvCxnSpPr>
          <p:nvPr/>
        </p:nvCxnSpPr>
        <p:spPr>
          <a:xfrm flipH="1">
            <a:off x="11169988" y="3942251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27195FD-74EA-2ED4-B7D9-4B874BFD2965}"/>
              </a:ext>
            </a:extLst>
          </p:cNvPr>
          <p:cNvSpPr txBox="1"/>
          <p:nvPr/>
        </p:nvSpPr>
        <p:spPr>
          <a:xfrm>
            <a:off x="8493999" y="5244002"/>
            <a:ext cx="815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Calibri"/>
              </a:rPr>
              <a:t>Actin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1D32926-7598-BE43-8149-04DEF7372FBC}"/>
              </a:ext>
            </a:extLst>
          </p:cNvPr>
          <p:cNvCxnSpPr>
            <a:cxnSpLocks/>
          </p:cNvCxnSpPr>
          <p:nvPr/>
        </p:nvCxnSpPr>
        <p:spPr>
          <a:xfrm>
            <a:off x="9761965" y="1921595"/>
            <a:ext cx="0" cy="291770"/>
          </a:xfrm>
          <a:prstGeom prst="straightConnector1">
            <a:avLst/>
          </a:prstGeom>
          <a:ln w="31750"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5B23D9A4-52F1-7514-B9C8-57A92E47B783}"/>
              </a:ext>
            </a:extLst>
          </p:cNvPr>
          <p:cNvCxnSpPr>
            <a:cxnSpLocks/>
          </p:cNvCxnSpPr>
          <p:nvPr/>
        </p:nvCxnSpPr>
        <p:spPr>
          <a:xfrm flipH="1">
            <a:off x="5285754" y="4700279"/>
            <a:ext cx="397526" cy="0"/>
          </a:xfrm>
          <a:prstGeom prst="straightConnector1">
            <a:avLst/>
          </a:prstGeom>
          <a:ln w="31750"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FCDDB99-DF77-FE72-8D47-6F6AE8D9F291}"/>
              </a:ext>
            </a:extLst>
          </p:cNvPr>
          <p:cNvSpPr txBox="1"/>
          <p:nvPr/>
        </p:nvSpPr>
        <p:spPr>
          <a:xfrm>
            <a:off x="5683280" y="4558304"/>
            <a:ext cx="1109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</a:rPr>
              <a:t>Membrane cut</a:t>
            </a:r>
          </a:p>
        </p:txBody>
      </p:sp>
    </p:spTree>
    <p:extLst>
      <p:ext uri="{BB962C8B-B14F-4D97-AF65-F5344CB8AC3E}">
        <p14:creationId xmlns:p14="http://schemas.microsoft.com/office/powerpoint/2010/main" val="35180521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3" descr="\\apollo\temp\Mariya\20181220_atpase_calret.bmp">
            <a:extLst>
              <a:ext uri="{FF2B5EF4-FFF2-40B4-BE49-F238E27FC236}">
                <a16:creationId xmlns:a16="http://schemas.microsoft.com/office/drawing/2014/main" id="{214B1C3C-613A-8606-3B45-419CBFF48ED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01" t="975" r="30531" b="14294"/>
          <a:stretch/>
        </p:blipFill>
        <p:spPr bwMode="auto">
          <a:xfrm>
            <a:off x="6774094" y="723959"/>
            <a:ext cx="4208888" cy="4654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2" descr="\\apollo\temp\Mariya\20181220_pdl1.bmp">
            <a:extLst>
              <a:ext uri="{FF2B5EF4-FFF2-40B4-BE49-F238E27FC236}">
                <a16:creationId xmlns:a16="http://schemas.microsoft.com/office/drawing/2014/main" id="{0C8F946F-A3EA-E008-C969-40D5B983A74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27" t="4687" r="30336" b="17537"/>
          <a:stretch/>
        </p:blipFill>
        <p:spPr bwMode="auto">
          <a:xfrm>
            <a:off x="2590800" y="609600"/>
            <a:ext cx="3505200" cy="533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36B08E3-F75D-ED2B-5F83-252D14A38884}"/>
              </a:ext>
            </a:extLst>
          </p:cNvPr>
          <p:cNvSpPr txBox="1"/>
          <p:nvPr/>
        </p:nvSpPr>
        <p:spPr>
          <a:xfrm flipH="1">
            <a:off x="2743201" y="6063734"/>
            <a:ext cx="4373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ure 3A Uncropped Western Blot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7000AC8-23CF-E271-B29A-AC5D70624BD1}"/>
              </a:ext>
            </a:extLst>
          </p:cNvPr>
          <p:cNvSpPr txBox="1"/>
          <p:nvPr/>
        </p:nvSpPr>
        <p:spPr>
          <a:xfrm>
            <a:off x="2565992" y="234493"/>
            <a:ext cx="1036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PD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A8AAE4-ACA8-4D44-3597-59F8CD424976}"/>
              </a:ext>
            </a:extLst>
          </p:cNvPr>
          <p:cNvSpPr txBox="1"/>
          <p:nvPr/>
        </p:nvSpPr>
        <p:spPr>
          <a:xfrm>
            <a:off x="6774094" y="407241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TPase and </a:t>
            </a:r>
            <a:r>
              <a:rPr lang="en-US" dirty="0" err="1"/>
              <a:t>Calret</a:t>
            </a:r>
            <a:endParaRPr lang="en-US" dirty="0"/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762F3A0E-FEFF-7CAA-DA89-4DE1B65F4058}"/>
              </a:ext>
            </a:extLst>
          </p:cNvPr>
          <p:cNvCxnSpPr>
            <a:cxnSpLocks/>
          </p:cNvCxnSpPr>
          <p:nvPr/>
        </p:nvCxnSpPr>
        <p:spPr>
          <a:xfrm>
            <a:off x="6003884" y="312055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6277ED26-1C51-6DE2-D96A-403F555DCCAC}"/>
              </a:ext>
            </a:extLst>
          </p:cNvPr>
          <p:cNvCxnSpPr>
            <a:cxnSpLocks/>
          </p:cNvCxnSpPr>
          <p:nvPr/>
        </p:nvCxnSpPr>
        <p:spPr>
          <a:xfrm flipH="1">
            <a:off x="5897237" y="2981974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FD43B8D-F243-4682-A3EA-F40D2E02834D}"/>
              </a:ext>
            </a:extLst>
          </p:cNvPr>
          <p:cNvCxnSpPr>
            <a:cxnSpLocks/>
          </p:cNvCxnSpPr>
          <p:nvPr/>
        </p:nvCxnSpPr>
        <p:spPr>
          <a:xfrm>
            <a:off x="10851482" y="422939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39ABED2E-91F8-7506-69FF-2EB4796164CF}"/>
              </a:ext>
            </a:extLst>
          </p:cNvPr>
          <p:cNvCxnSpPr>
            <a:cxnSpLocks/>
          </p:cNvCxnSpPr>
          <p:nvPr/>
        </p:nvCxnSpPr>
        <p:spPr>
          <a:xfrm flipH="1">
            <a:off x="10744835" y="3092858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71148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06D17-E3DB-FC68-2479-BE2038A34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550E99F-40AF-B23E-804C-FC4C3EA2B905}"/>
              </a:ext>
            </a:extLst>
          </p:cNvPr>
          <p:cNvSpPr txBox="1"/>
          <p:nvPr/>
        </p:nvSpPr>
        <p:spPr>
          <a:xfrm flipH="1">
            <a:off x="2743201" y="6063734"/>
            <a:ext cx="4373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ure 3B Uncropped Western Blots</a:t>
            </a:r>
          </a:p>
        </p:txBody>
      </p:sp>
      <p:pic>
        <p:nvPicPr>
          <p:cNvPr id="7" name="Picture 2" descr="P:\Projects\2018\PdL1\lifecycle\pdl1 WB jan-mar\Pdl1 dose response Mar 30 2018 PDL1 48h.bmp">
            <a:extLst>
              <a:ext uri="{FF2B5EF4-FFF2-40B4-BE49-F238E27FC236}">
                <a16:creationId xmlns:a16="http://schemas.microsoft.com/office/drawing/2014/main" id="{799F55F6-FA2D-8406-86A6-9A2AE1728BB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39" t="48306" r="25994" b="10182"/>
          <a:stretch/>
        </p:blipFill>
        <p:spPr bwMode="auto">
          <a:xfrm>
            <a:off x="6251919" y="1445808"/>
            <a:ext cx="4267200" cy="28351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2" descr="P:\Projects\2018\PdL1\lifecycle\pdl1 WB jan-mar\Pdl1 dose response Mar 29 2018 PDL1.bmp">
            <a:extLst>
              <a:ext uri="{FF2B5EF4-FFF2-40B4-BE49-F238E27FC236}">
                <a16:creationId xmlns:a16="http://schemas.microsoft.com/office/drawing/2014/main" id="{E6022D78-2A2C-9C91-DBCD-A85FE33C7F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50" t="35684" r="22067" b="11189"/>
          <a:stretch/>
        </p:blipFill>
        <p:spPr bwMode="auto">
          <a:xfrm>
            <a:off x="1899684" y="1417638"/>
            <a:ext cx="3965978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3" descr="P:\Projects\2018\PdL1\lifecycle\pdl1 WB jan-mar\Pdl1 dose response Mar 29 2018 cntrl.bmp">
            <a:extLst>
              <a:ext uri="{FF2B5EF4-FFF2-40B4-BE49-F238E27FC236}">
                <a16:creationId xmlns:a16="http://schemas.microsoft.com/office/drawing/2014/main" id="{6ADA52CB-D2D6-449C-AD9D-E61A13B301F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95" t="44572" r="30276" b="17694"/>
          <a:stretch/>
        </p:blipFill>
        <p:spPr bwMode="auto">
          <a:xfrm>
            <a:off x="6324601" y="4280972"/>
            <a:ext cx="3581399" cy="25770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B206922-6A05-2821-B202-0FDDDCF4EAFE}"/>
              </a:ext>
            </a:extLst>
          </p:cNvPr>
          <p:cNvSpPr txBox="1"/>
          <p:nvPr/>
        </p:nvSpPr>
        <p:spPr>
          <a:xfrm>
            <a:off x="1670961" y="2266890"/>
            <a:ext cx="4539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  <a:cs typeface="Arial" charset="0"/>
              </a:rPr>
              <a:t>PDL1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  <a:cs typeface="Arial" charset="0"/>
              </a:rPr>
              <a:t>24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A0EC1EE-E8C3-42A0-1BF1-E7FF90B15855}"/>
              </a:ext>
            </a:extLst>
          </p:cNvPr>
          <p:cNvSpPr txBox="1"/>
          <p:nvPr/>
        </p:nvSpPr>
        <p:spPr>
          <a:xfrm>
            <a:off x="5819505" y="5181601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  <a:cs typeface="Arial" charset="0"/>
              </a:rPr>
              <a:t>ATPas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07BE32-2C6E-B200-2632-EF78AD7ED743}"/>
              </a:ext>
            </a:extLst>
          </p:cNvPr>
          <p:cNvSpPr txBox="1"/>
          <p:nvPr/>
        </p:nvSpPr>
        <p:spPr>
          <a:xfrm>
            <a:off x="5819505" y="5537769"/>
            <a:ext cx="5004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 err="1">
                <a:solidFill>
                  <a:srgbClr val="000000"/>
                </a:solidFill>
                <a:cs typeface="Arial" charset="0"/>
              </a:rPr>
              <a:t>Calret</a:t>
            </a:r>
            <a:endParaRPr lang="en-US" sz="1000" b="1">
              <a:solidFill>
                <a:srgbClr val="000000"/>
              </a:solidFill>
              <a:cs typeface="Arial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F83705-A5BB-4F51-50D1-B5A48A0AFA66}"/>
              </a:ext>
            </a:extLst>
          </p:cNvPr>
          <p:cNvSpPr txBox="1"/>
          <p:nvPr/>
        </p:nvSpPr>
        <p:spPr>
          <a:xfrm>
            <a:off x="5819505" y="2266890"/>
            <a:ext cx="914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  <a:cs typeface="Arial" charset="0"/>
              </a:rPr>
              <a:t>PDL1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>
                <a:solidFill>
                  <a:srgbClr val="000000"/>
                </a:solidFill>
                <a:cs typeface="Arial" charset="0"/>
              </a:rPr>
              <a:t>48h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3934C012-2136-4457-6A88-2358DD8BDF73}"/>
              </a:ext>
            </a:extLst>
          </p:cNvPr>
          <p:cNvCxnSpPr>
            <a:cxnSpLocks/>
          </p:cNvCxnSpPr>
          <p:nvPr/>
        </p:nvCxnSpPr>
        <p:spPr>
          <a:xfrm>
            <a:off x="5727389" y="1318922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C2FC85BF-2CEE-6A23-583F-A73D3B867A13}"/>
              </a:ext>
            </a:extLst>
          </p:cNvPr>
          <p:cNvCxnSpPr>
            <a:cxnSpLocks/>
          </p:cNvCxnSpPr>
          <p:nvPr/>
        </p:nvCxnSpPr>
        <p:spPr>
          <a:xfrm flipH="1">
            <a:off x="5620742" y="4451178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CBC05ABB-DFC2-A0EB-8460-44A56C3373FC}"/>
              </a:ext>
            </a:extLst>
          </p:cNvPr>
          <p:cNvCxnSpPr>
            <a:cxnSpLocks/>
          </p:cNvCxnSpPr>
          <p:nvPr/>
        </p:nvCxnSpPr>
        <p:spPr>
          <a:xfrm>
            <a:off x="10318225" y="1148716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1F19505-C4DE-3F07-DF81-F9180C0E5807}"/>
              </a:ext>
            </a:extLst>
          </p:cNvPr>
          <p:cNvCxnSpPr>
            <a:cxnSpLocks/>
          </p:cNvCxnSpPr>
          <p:nvPr/>
        </p:nvCxnSpPr>
        <p:spPr>
          <a:xfrm flipH="1">
            <a:off x="10519119" y="4195912"/>
            <a:ext cx="397526" cy="0"/>
          </a:xfrm>
          <a:prstGeom prst="straightConnector1">
            <a:avLst/>
          </a:prstGeom>
          <a:ln w="31750"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68A25EA-69F5-8952-A73D-AB14084BAABA}"/>
              </a:ext>
            </a:extLst>
          </p:cNvPr>
          <p:cNvSpPr txBox="1"/>
          <p:nvPr/>
        </p:nvSpPr>
        <p:spPr>
          <a:xfrm>
            <a:off x="10916645" y="4057412"/>
            <a:ext cx="1109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</a:rPr>
              <a:t>Membrane cut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C071FEF-BBD1-9139-F92E-46E60543EF56}"/>
              </a:ext>
            </a:extLst>
          </p:cNvPr>
          <p:cNvCxnSpPr>
            <a:cxnSpLocks/>
          </p:cNvCxnSpPr>
          <p:nvPr/>
        </p:nvCxnSpPr>
        <p:spPr>
          <a:xfrm>
            <a:off x="9503013" y="4159408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6844495-1E36-9892-C8F4-F092AD9F8CEC}"/>
              </a:ext>
            </a:extLst>
          </p:cNvPr>
          <p:cNvCxnSpPr>
            <a:cxnSpLocks/>
          </p:cNvCxnSpPr>
          <p:nvPr/>
        </p:nvCxnSpPr>
        <p:spPr>
          <a:xfrm flipH="1">
            <a:off x="9503013" y="6754815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74580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550E99F-40AF-B23E-804C-FC4C3EA2B905}"/>
              </a:ext>
            </a:extLst>
          </p:cNvPr>
          <p:cNvSpPr txBox="1"/>
          <p:nvPr/>
        </p:nvSpPr>
        <p:spPr>
          <a:xfrm flipH="1">
            <a:off x="2743201" y="6063734"/>
            <a:ext cx="4373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ure 6A Uncropped Western Blots</a:t>
            </a:r>
          </a:p>
        </p:txBody>
      </p:sp>
      <p:pic>
        <p:nvPicPr>
          <p:cNvPr id="6" name="Picture 2" descr="C:\Users\htplab\Desktop\users\Mariya\2020\20201006 PDL1.bmp">
            <a:extLst>
              <a:ext uri="{FF2B5EF4-FFF2-40B4-BE49-F238E27FC236}">
                <a16:creationId xmlns:a16="http://schemas.microsoft.com/office/drawing/2014/main" id="{21256DF2-3654-1B6C-2BD2-04E71383A0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3" t="-2266" r="17046" b="51306"/>
          <a:stretch/>
        </p:blipFill>
        <p:spPr bwMode="auto">
          <a:xfrm>
            <a:off x="2209800" y="1654139"/>
            <a:ext cx="6858000" cy="33093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0822F2B-947E-4929-8643-19EC4B59D967}"/>
              </a:ext>
            </a:extLst>
          </p:cNvPr>
          <p:cNvSpPr txBox="1"/>
          <p:nvPr/>
        </p:nvSpPr>
        <p:spPr>
          <a:xfrm>
            <a:off x="2979422" y="1393726"/>
            <a:ext cx="1950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Inpu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1860E23-D70C-B1C5-65E2-984AE6C381E3}"/>
              </a:ext>
            </a:extLst>
          </p:cNvPr>
          <p:cNvSpPr txBox="1"/>
          <p:nvPr/>
        </p:nvSpPr>
        <p:spPr>
          <a:xfrm>
            <a:off x="5943601" y="1393726"/>
            <a:ext cx="1950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Elute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2C486D1B-779A-0A8C-6949-E94EC3E35E1E}"/>
              </a:ext>
            </a:extLst>
          </p:cNvPr>
          <p:cNvCxnSpPr>
            <a:cxnSpLocks/>
          </p:cNvCxnSpPr>
          <p:nvPr/>
        </p:nvCxnSpPr>
        <p:spPr>
          <a:xfrm>
            <a:off x="8971385" y="1536710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778F6312-2B8C-3F8F-E880-2F4076B1E510}"/>
              </a:ext>
            </a:extLst>
          </p:cNvPr>
          <p:cNvCxnSpPr>
            <a:cxnSpLocks/>
          </p:cNvCxnSpPr>
          <p:nvPr/>
        </p:nvCxnSpPr>
        <p:spPr>
          <a:xfrm flipH="1">
            <a:off x="9106062" y="4897661"/>
            <a:ext cx="397526" cy="0"/>
          </a:xfrm>
          <a:prstGeom prst="straightConnector1">
            <a:avLst/>
          </a:prstGeom>
          <a:ln w="31750"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C19AFDD1-88EA-340F-D103-C90BF12A3BA2}"/>
              </a:ext>
            </a:extLst>
          </p:cNvPr>
          <p:cNvCxnSpPr>
            <a:cxnSpLocks/>
          </p:cNvCxnSpPr>
          <p:nvPr/>
        </p:nvCxnSpPr>
        <p:spPr>
          <a:xfrm flipH="1">
            <a:off x="9106062" y="1845797"/>
            <a:ext cx="397526" cy="0"/>
          </a:xfrm>
          <a:prstGeom prst="straightConnector1">
            <a:avLst/>
          </a:prstGeom>
          <a:ln w="31750">
            <a:solidFill>
              <a:srgbClr val="C0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10EB701-6631-066A-3AB6-E5C679895104}"/>
              </a:ext>
            </a:extLst>
          </p:cNvPr>
          <p:cNvSpPr txBox="1"/>
          <p:nvPr/>
        </p:nvSpPr>
        <p:spPr>
          <a:xfrm>
            <a:off x="9493619" y="1682595"/>
            <a:ext cx="1109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</a:rPr>
              <a:t>Membrane cu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6BA49F-DAB4-93AA-972D-BD55740A84EC}"/>
              </a:ext>
            </a:extLst>
          </p:cNvPr>
          <p:cNvSpPr txBox="1"/>
          <p:nvPr/>
        </p:nvSpPr>
        <p:spPr>
          <a:xfrm>
            <a:off x="9493618" y="4759161"/>
            <a:ext cx="1109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</a:rPr>
              <a:t>Membrane cut</a:t>
            </a:r>
          </a:p>
        </p:txBody>
      </p:sp>
    </p:spTree>
    <p:extLst>
      <p:ext uri="{BB962C8B-B14F-4D97-AF65-F5344CB8AC3E}">
        <p14:creationId xmlns:p14="http://schemas.microsoft.com/office/powerpoint/2010/main" val="19233456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itle 26">
            <a:extLst>
              <a:ext uri="{FF2B5EF4-FFF2-40B4-BE49-F238E27FC236}">
                <a16:creationId xmlns:a16="http://schemas.microsoft.com/office/drawing/2014/main" id="{1B949BCB-0505-F65E-73DF-B0C0A320DE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28" name="Picture 28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EA2C3110-07AA-D7A2-A16F-3B3754D25E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0062" y="1988419"/>
            <a:ext cx="5807587" cy="3540586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B76898AD-3111-F8C5-F12C-DBBF0BEEF315}"/>
              </a:ext>
            </a:extLst>
          </p:cNvPr>
          <p:cNvSpPr txBox="1"/>
          <p:nvPr/>
        </p:nvSpPr>
        <p:spPr>
          <a:xfrm flipH="1">
            <a:off x="3909059" y="5943695"/>
            <a:ext cx="437388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Figure 6B Raw Uncropped Western Blots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F377958F-C591-AEBB-AE0D-1E0C0B81CF1F}"/>
              </a:ext>
            </a:extLst>
          </p:cNvPr>
          <p:cNvCxnSpPr>
            <a:cxnSpLocks/>
          </p:cNvCxnSpPr>
          <p:nvPr/>
        </p:nvCxnSpPr>
        <p:spPr>
          <a:xfrm>
            <a:off x="6834241" y="2195928"/>
            <a:ext cx="0" cy="29177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C32CB758-F99A-429F-3571-49A51406CCA6}"/>
              </a:ext>
            </a:extLst>
          </p:cNvPr>
          <p:cNvCxnSpPr>
            <a:cxnSpLocks/>
          </p:cNvCxnSpPr>
          <p:nvPr/>
        </p:nvCxnSpPr>
        <p:spPr>
          <a:xfrm flipH="1">
            <a:off x="6876773" y="5375805"/>
            <a:ext cx="397526" cy="0"/>
          </a:xfrm>
          <a:prstGeom prst="straightConnector1">
            <a:avLst/>
          </a:prstGeom>
          <a:ln w="31750">
            <a:solidFill>
              <a:schemeClr val="accent1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0849907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1:  </a:t>
            </a:r>
            <a:endParaRPr lang="en-US" dirty="0"/>
          </a:p>
        </p:txBody>
      </p:sp>
      <p:pic>
        <p:nvPicPr>
          <p:cNvPr id="5" name="Picture 5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023171F3-2ED9-1766-4289-1EB6F53D57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0" y="1454617"/>
            <a:ext cx="8115300" cy="474886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F091545-4733-05F5-3B84-721524FF3BA2}"/>
              </a:ext>
            </a:extLst>
          </p:cNvPr>
          <p:cNvSpPr txBox="1"/>
          <p:nvPr/>
        </p:nvSpPr>
        <p:spPr>
          <a:xfrm>
            <a:off x="8215371" y="277246"/>
            <a:ext cx="3924297" cy="618630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ea typeface="+mn-lt"/>
                <a:cs typeface="+mn-lt"/>
              </a:rPr>
              <a:t>(A) A scheme describing timeline of the treatment of CHO-PD-L1 cells with PD-L1 inhibitors and labeling with Hoechst, </a:t>
            </a:r>
            <a:r>
              <a:rPr lang="en-US" dirty="0" err="1">
                <a:ea typeface="+mn-lt"/>
                <a:cs typeface="+mn-lt"/>
              </a:rPr>
              <a:t>Calcein</a:t>
            </a:r>
            <a:r>
              <a:rPr lang="en-US" dirty="0">
                <a:ea typeface="+mn-lt"/>
                <a:cs typeface="+mn-lt"/>
              </a:rPr>
              <a:t> AM or anti-PD-L1 antibody. The cells were treated with PD-L1 inhibitors (1 </a:t>
            </a:r>
            <a:r>
              <a:rPr lang="en-GB" dirty="0">
                <a:ea typeface="+mn-lt"/>
                <a:cs typeface="+mn-lt"/>
              </a:rPr>
              <a:t>µ</a:t>
            </a:r>
            <a:r>
              <a:rPr lang="en-US" dirty="0">
                <a:ea typeface="+mn-lt"/>
                <a:cs typeface="+mn-lt"/>
              </a:rPr>
              <a:t>M final concentration) for 24 hours and stained with Hoechst and </a:t>
            </a:r>
            <a:r>
              <a:rPr lang="en-US" dirty="0" err="1">
                <a:ea typeface="+mn-lt"/>
                <a:cs typeface="+mn-lt"/>
              </a:rPr>
              <a:t>Calcein</a:t>
            </a:r>
            <a:r>
              <a:rPr lang="en-US" dirty="0">
                <a:ea typeface="+mn-lt"/>
                <a:cs typeface="+mn-lt"/>
              </a:rPr>
              <a:t> AM (added 30 min prior to the end of treatment). Live-cell imaging was conducted at room temperature (to slow down endocytosis) shortly after the cells were stained with </a:t>
            </a:r>
            <a:r>
              <a:rPr lang="en-US" dirty="0">
                <a:cs typeface="Calibri"/>
              </a:rPr>
              <a:t>anti-PD-L1 antibody (ab209960, conjugated with Alexa Fluor 647) to detect PD-L1 remaining on the cell surface (no permeabilization was performed).</a:t>
            </a:r>
            <a:endParaRPr lang="en-US"/>
          </a:p>
          <a:p>
            <a:r>
              <a:rPr lang="en-US" dirty="0">
                <a:cs typeface="Calibri"/>
              </a:rPr>
              <a:t>(B) Confocal images of CHO cells expressing PD-L1. Regardless of the treatment, significant amount of PD-L1 was detected at the cell surface despite prolonged (24 hours) incubation with inhibitors.    </a:t>
            </a:r>
            <a:endParaRPr lang="en-US">
              <a:ea typeface="+mn-lt"/>
              <a:cs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2812372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0F129-0BF2-7557-404E-D71DE7B4C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ea typeface="+mj-lt"/>
                <a:cs typeface="+mj-lt"/>
              </a:rPr>
              <a:t>Supplemental Figure 2:  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4686EE-45A0-D85C-2CD3-4AFA0AF0647E}"/>
              </a:ext>
            </a:extLst>
          </p:cNvPr>
          <p:cNvSpPr txBox="1"/>
          <p:nvPr/>
        </p:nvSpPr>
        <p:spPr>
          <a:xfrm>
            <a:off x="419158" y="5680870"/>
            <a:ext cx="11415597" cy="12003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ea typeface="+mn-lt"/>
                <a:cs typeface="+mn-lt"/>
              </a:rPr>
              <a:t>Confocal images of CHO cells expressing either PD-L1 or PD1 (negative control for detection antibody). The cells were treated with PD-L1 inhibitors (1 </a:t>
            </a:r>
            <a:r>
              <a:rPr lang="en-GB" dirty="0">
                <a:ea typeface="+mn-lt"/>
                <a:cs typeface="+mn-lt"/>
              </a:rPr>
              <a:t>µ</a:t>
            </a:r>
            <a:r>
              <a:rPr lang="en-US" dirty="0">
                <a:ea typeface="+mn-lt"/>
                <a:cs typeface="+mn-lt"/>
              </a:rPr>
              <a:t>M final concentration) for 6 hours or DMSO, then fixed in methanol, blocked (2% BSA)  and stained with </a:t>
            </a:r>
            <a:r>
              <a:rPr lang="en-US" dirty="0">
                <a:cs typeface="Calibri"/>
              </a:rPr>
              <a:t>anti-PD-L1 antibody (ab209960, conjugated with Alexa Fluor 647) to detect PD-L1. Noticeable amount of PD-L1 was detected at the cell surface </a:t>
            </a:r>
            <a:r>
              <a:rPr lang="en-US" dirty="0">
                <a:ea typeface="+mn-lt"/>
                <a:cs typeface="+mn-lt"/>
              </a:rPr>
              <a:t>regardless of the inhibitor applied</a:t>
            </a:r>
            <a:r>
              <a:rPr lang="en-US" dirty="0">
                <a:cs typeface="Calibri"/>
              </a:rPr>
              <a:t>.    </a:t>
            </a:r>
            <a:endParaRPr lang="en-US" dirty="0">
              <a:ea typeface="+mn-lt"/>
              <a:cs typeface="+mn-lt"/>
            </a:endParaRPr>
          </a:p>
        </p:txBody>
      </p:sp>
      <p:pic>
        <p:nvPicPr>
          <p:cNvPr id="7" name="Picture 7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799F8B3F-FC8C-048C-149D-D45E13EF60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544" y="1325075"/>
            <a:ext cx="11288485" cy="4343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9930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95D71ED60800B4686281613B0A76157" ma:contentTypeVersion="14" ma:contentTypeDescription="Create a new document." ma:contentTypeScope="" ma:versionID="2150438b1f42998354080f9a8264df06">
  <xsd:schema xmlns:xsd="http://www.w3.org/2001/XMLSchema" xmlns:xs="http://www.w3.org/2001/XMLSchema" xmlns:p="http://schemas.microsoft.com/office/2006/metadata/properties" xmlns:ns3="9a1042b1-3534-4971-a9b2-513420132232" xmlns:ns4="e28efc4d-c332-4bf1-b9a3-9584c7939d4a" targetNamespace="http://schemas.microsoft.com/office/2006/metadata/properties" ma:root="true" ma:fieldsID="9d09bba1c8903edcd1c98209bb52f107" ns3:_="" ns4:_="">
    <xsd:import namespace="9a1042b1-3534-4971-a9b2-513420132232"/>
    <xsd:import namespace="e28efc4d-c332-4bf1-b9a3-9584c7939d4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LengthInSeconds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1042b1-3534-4971-a9b2-513420132232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8efc4d-c332-4bf1-b9a3-9584c7939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KeyPoints" ma:index="2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8E334DA-B6EC-42DF-9D7F-84BE648C3FA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B920852-386A-4B19-B337-16131B578091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1CD17A88-5F87-4814-8D99-B0F378B1D8F3}">
  <ds:schemaRefs>
    <ds:schemaRef ds:uri="9a1042b1-3534-4971-a9b2-513420132232"/>
    <ds:schemaRef ds:uri="e28efc4d-c332-4bf1-b9a3-9584c7939d4a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066</Words>
  <Application>Microsoft Office PowerPoint</Application>
  <PresentationFormat>Widescreen</PresentationFormat>
  <Paragraphs>65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rebuchet MS</vt:lpstr>
      <vt:lpstr>Office Theme</vt:lpstr>
      <vt:lpstr>Supplemental data information</vt:lpstr>
      <vt:lpstr>Western Blot Process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l Figure 1:  </vt:lpstr>
      <vt:lpstr>Supplemental Figure 2:  </vt:lpstr>
      <vt:lpstr>Supplemental Figure 3:  </vt:lpstr>
      <vt:lpstr>Supplemental Figure 4:  </vt:lpstr>
      <vt:lpstr>Supplemental Figure 5:  </vt:lpstr>
      <vt:lpstr>Supplemental Figure 6:  </vt:lpstr>
      <vt:lpstr>Supplemental Figure 7: for Pulse chase (Methods section, page 20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 information</dc:title>
  <dc:creator>Ilean Chai</dc:creator>
  <cp:lastModifiedBy>Mariya Morar</cp:lastModifiedBy>
  <cp:revision>619</cp:revision>
  <dcterms:created xsi:type="dcterms:W3CDTF">2022-08-09T00:23:38Z</dcterms:created>
  <dcterms:modified xsi:type="dcterms:W3CDTF">2022-11-12T23:01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18c1083-8924-401d-97ae-40f5eed0fcd8_Enabled">
    <vt:lpwstr>true</vt:lpwstr>
  </property>
  <property fmtid="{D5CDD505-2E9C-101B-9397-08002B2CF9AE}" pid="3" name="MSIP_Label_418c1083-8924-401d-97ae-40f5eed0fcd8_SetDate">
    <vt:lpwstr>2022-08-12T22:41:27Z</vt:lpwstr>
  </property>
  <property fmtid="{D5CDD505-2E9C-101B-9397-08002B2CF9AE}" pid="4" name="MSIP_Label_418c1083-8924-401d-97ae-40f5eed0fcd8_Method">
    <vt:lpwstr>Standard</vt:lpwstr>
  </property>
  <property fmtid="{D5CDD505-2E9C-101B-9397-08002B2CF9AE}" pid="5" name="MSIP_Label_418c1083-8924-401d-97ae-40f5eed0fcd8_Name">
    <vt:lpwstr>418c1083-8924-401d-97ae-40f5eed0fcd8</vt:lpwstr>
  </property>
  <property fmtid="{D5CDD505-2E9C-101B-9397-08002B2CF9AE}" pid="6" name="MSIP_Label_418c1083-8924-401d-97ae-40f5eed0fcd8_SiteId">
    <vt:lpwstr>a5a8bcaa-3292-41e6-b735-5e8b21f4dbfd</vt:lpwstr>
  </property>
  <property fmtid="{D5CDD505-2E9C-101B-9397-08002B2CF9AE}" pid="7" name="MSIP_Label_418c1083-8924-401d-97ae-40f5eed0fcd8_ActionId">
    <vt:lpwstr>291960c0-b646-4c61-ac01-0823bfe37276</vt:lpwstr>
  </property>
  <property fmtid="{D5CDD505-2E9C-101B-9397-08002B2CF9AE}" pid="8" name="MSIP_Label_418c1083-8924-401d-97ae-40f5eed0fcd8_ContentBits">
    <vt:lpwstr>0</vt:lpwstr>
  </property>
  <property fmtid="{D5CDD505-2E9C-101B-9397-08002B2CF9AE}" pid="9" name="ContentTypeId">
    <vt:lpwstr>0x010100995D71ED60800B4686281613B0A76157</vt:lpwstr>
  </property>
</Properties>
</file>